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334" r:id="rId3"/>
    <p:sldId id="260" r:id="rId4"/>
    <p:sldId id="261" r:id="rId5"/>
    <p:sldId id="335" r:id="rId6"/>
    <p:sldId id="258" r:id="rId7"/>
    <p:sldId id="259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322" r:id="rId17"/>
    <p:sldId id="323" r:id="rId18"/>
    <p:sldId id="324" r:id="rId19"/>
    <p:sldId id="325" r:id="rId20"/>
    <p:sldId id="326" r:id="rId21"/>
    <p:sldId id="327" r:id="rId22"/>
    <p:sldId id="328" r:id="rId23"/>
    <p:sldId id="329" r:id="rId24"/>
    <p:sldId id="330" r:id="rId25"/>
    <p:sldId id="331" r:id="rId26"/>
    <p:sldId id="332" r:id="rId27"/>
    <p:sldId id="333" r:id="rId28"/>
    <p:sldId id="270" r:id="rId29"/>
    <p:sldId id="271" r:id="rId30"/>
    <p:sldId id="272" r:id="rId31"/>
    <p:sldId id="273" r:id="rId32"/>
    <p:sldId id="274" r:id="rId33"/>
    <p:sldId id="275" r:id="rId34"/>
    <p:sldId id="276" r:id="rId35"/>
    <p:sldId id="277" r:id="rId36"/>
    <p:sldId id="278" r:id="rId37"/>
    <p:sldId id="279" r:id="rId38"/>
    <p:sldId id="280" r:id="rId39"/>
    <p:sldId id="281" r:id="rId40"/>
    <p:sldId id="282" r:id="rId41"/>
    <p:sldId id="283" r:id="rId42"/>
    <p:sldId id="284" r:id="rId43"/>
    <p:sldId id="285" r:id="rId44"/>
    <p:sldId id="286" r:id="rId45"/>
    <p:sldId id="287" r:id="rId46"/>
    <p:sldId id="288" r:id="rId47"/>
    <p:sldId id="289" r:id="rId48"/>
    <p:sldId id="290" r:id="rId49"/>
    <p:sldId id="291" r:id="rId50"/>
    <p:sldId id="292" r:id="rId51"/>
    <p:sldId id="293" r:id="rId52"/>
    <p:sldId id="294" r:id="rId53"/>
    <p:sldId id="295" r:id="rId54"/>
    <p:sldId id="296" r:id="rId55"/>
    <p:sldId id="297" r:id="rId56"/>
    <p:sldId id="298" r:id="rId57"/>
    <p:sldId id="299" r:id="rId58"/>
    <p:sldId id="300" r:id="rId59"/>
    <p:sldId id="301" r:id="rId60"/>
    <p:sldId id="302" r:id="rId61"/>
    <p:sldId id="303" r:id="rId62"/>
    <p:sldId id="304" r:id="rId63"/>
    <p:sldId id="305" r:id="rId64"/>
    <p:sldId id="306" r:id="rId65"/>
    <p:sldId id="307" r:id="rId66"/>
    <p:sldId id="308" r:id="rId67"/>
    <p:sldId id="309" r:id="rId68"/>
    <p:sldId id="310" r:id="rId69"/>
    <p:sldId id="311" r:id="rId70"/>
    <p:sldId id="312" r:id="rId71"/>
    <p:sldId id="313" r:id="rId72"/>
    <p:sldId id="314" r:id="rId73"/>
    <p:sldId id="315" r:id="rId74"/>
    <p:sldId id="316" r:id="rId75"/>
    <p:sldId id="317" r:id="rId76"/>
    <p:sldId id="318" r:id="rId77"/>
    <p:sldId id="319" r:id="rId78"/>
    <p:sldId id="320" r:id="rId7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47" autoAdjust="0"/>
    <p:restoredTop sz="94660"/>
  </p:normalViewPr>
  <p:slideViewPr>
    <p:cSldViewPr showGuides="1">
      <p:cViewPr>
        <p:scale>
          <a:sx n="50" d="100"/>
          <a:sy n="50" d="100"/>
        </p:scale>
        <p:origin x="-1680" y="-3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6" Type="http://schemas.openxmlformats.org/officeDocument/2006/relationships/slide" Target="slides/slide75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82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145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921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535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84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31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873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653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57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930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311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7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0490E-9CD9-43F1-9014-D0B33CDEB409}" type="datetimeFigureOut">
              <a:rPr lang="en-US" smtClean="0"/>
              <a:t>1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94FC0-8F6C-4DEC-9FF8-381EF096A9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8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emf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emf"/><Relationship Id="rId1" Type="http://schemas.openxmlformats.org/officeDocument/2006/relationships/slideLayout" Target="../slideLayouts/slideLayout7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emf"/><Relationship Id="rId1" Type="http://schemas.openxmlformats.org/officeDocument/2006/relationships/slideLayout" Target="../slideLayouts/slideLayout7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7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emf"/><Relationship Id="rId1" Type="http://schemas.openxmlformats.org/officeDocument/2006/relationships/slideLayout" Target="../slideLayouts/slideLayout7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emf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emf"/><Relationship Id="rId1" Type="http://schemas.openxmlformats.org/officeDocument/2006/relationships/slideLayout" Target="../slideLayouts/slideLayout7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7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emf"/><Relationship Id="rId1" Type="http://schemas.openxmlformats.org/officeDocument/2006/relationships/slideLayout" Target="../slideLayouts/slideLayout7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emf"/><Relationship Id="rId1" Type="http://schemas.openxmlformats.org/officeDocument/2006/relationships/slideLayout" Target="../slideLayouts/slideLayout7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emf"/><Relationship Id="rId1" Type="http://schemas.openxmlformats.org/officeDocument/2006/relationships/slideLayout" Target="../slideLayouts/slideLayout7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emf"/><Relationship Id="rId1" Type="http://schemas.openxmlformats.org/officeDocument/2006/relationships/slideLayout" Target="../slideLayouts/slideLayout7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7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7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7.xml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980337"/>
            <a:ext cx="8229600" cy="1754326"/>
          </a:xfrm>
        </p:spPr>
        <p:txBody>
          <a:bodyPr>
            <a:spAutoFit/>
          </a:bodyPr>
          <a:lstStyle/>
          <a:p>
            <a:r>
              <a:rPr lang="en-US" sz="3600" b="1" dirty="0" smtClean="0"/>
              <a:t>S2</a:t>
            </a:r>
            <a:br>
              <a:rPr lang="en-US" sz="3600" b="1" dirty="0" smtClean="0"/>
            </a:br>
            <a:r>
              <a:rPr lang="en-US" sz="3600" b="1" dirty="0" smtClean="0"/>
              <a:t>Measured </a:t>
            </a:r>
            <a:r>
              <a:rPr lang="en-US" sz="3600" b="1" dirty="0" smtClean="0"/>
              <a:t>and Modeled Profiles</a:t>
            </a:r>
            <a:br>
              <a:rPr lang="en-US" sz="3600" b="1" dirty="0" smtClean="0"/>
            </a:br>
            <a:r>
              <a:rPr lang="en-US" sz="3600" b="1" dirty="0" smtClean="0"/>
              <a:t>(</a:t>
            </a:r>
            <a:r>
              <a:rPr lang="en-US" sz="2800" b="1" dirty="0" smtClean="0"/>
              <a:t>note: vertical axis in </a:t>
            </a:r>
            <a:r>
              <a:rPr lang="en-US" sz="2800" b="1" dirty="0" err="1" smtClean="0"/>
              <a:t>microtesla</a:t>
            </a:r>
            <a:r>
              <a:rPr lang="en-US" sz="2800" b="1" dirty="0" smtClean="0"/>
              <a:t> (</a:t>
            </a:r>
            <a:r>
              <a:rPr lang="en-US" sz="2800" b="1" dirty="0" err="1" smtClean="0">
                <a:latin typeface="Symbol" panose="05050102010706020507" pitchFamily="18" charset="2"/>
              </a:rPr>
              <a:t>m</a:t>
            </a:r>
            <a:r>
              <a:rPr lang="en-US" sz="2800" b="1" dirty="0" err="1" smtClean="0"/>
              <a:t>T</a:t>
            </a:r>
            <a:r>
              <a:rPr lang="en-US" sz="2800" b="1" dirty="0" smtClean="0"/>
              <a:t>))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36935208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219925" y="15389"/>
            <a:ext cx="896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65304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203895" y="15389"/>
            <a:ext cx="912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64646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57408" y="15389"/>
            <a:ext cx="958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78059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79850" y="15389"/>
            <a:ext cx="936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13669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3594" y="1538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32486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28554" y="15389"/>
            <a:ext cx="987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163774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BenS1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25348" y="15389"/>
            <a:ext cx="990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09033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BenS1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59011" y="15389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98536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22142" y="15389"/>
            <a:ext cx="9941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Q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02992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52599" y="15389"/>
            <a:ext cx="96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969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1</a:t>
            </a:r>
            <a:endParaRPr lang="en-US" sz="20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8144583" y="15389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199812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71835" y="15389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902466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5423" y="15389"/>
            <a:ext cx="950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835224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30157" y="15389"/>
            <a:ext cx="986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266106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46187" y="15389"/>
            <a:ext cx="97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246367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0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3594" y="15389"/>
            <a:ext cx="1072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W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934327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57408" y="15389"/>
            <a:ext cx="958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324306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5423" y="15389"/>
            <a:ext cx="9509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125675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70232" y="15389"/>
            <a:ext cx="946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</a:t>
            </a:r>
            <a:r>
              <a:rPr lang="en-US" smtClean="0"/>
              <a:t>Fig Z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10003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11534" y="15389"/>
            <a:ext cx="1104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2227932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8</a:t>
            </a:r>
            <a:endParaRPr lang="en-US" sz="2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019549" y="15389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2527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0613" y="1538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67437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19</a:t>
            </a:r>
            <a:endParaRPr lang="en-US" sz="2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022820" y="15389"/>
            <a:ext cx="10935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576129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41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D2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1916" y="15389"/>
            <a:ext cx="1114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078857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0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32373" y="15389"/>
            <a:ext cx="108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799778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02</a:t>
            </a:r>
            <a:endParaRPr lang="en-US" sz="2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038785" y="15389"/>
            <a:ext cx="1077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71123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0377" y="15389"/>
            <a:ext cx="1115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985083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0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0313" y="1538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9517720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0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86875" y="15389"/>
            <a:ext cx="1029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5455921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RSRS1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68280" y="15389"/>
            <a:ext cx="1048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179574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RSRS1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4358" y="15389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298929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RSRS1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6800" y="15389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95177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0613" y="1538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638114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RSRS1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47414" y="15389"/>
            <a:ext cx="1168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4179642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RSRS1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95504" y="1538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407282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310" y="291010"/>
            <a:ext cx="8663380" cy="62759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15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RSRS2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94863" y="15389"/>
            <a:ext cx="1121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108764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5961" y="15389"/>
            <a:ext cx="10903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1, Fig A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385380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91657" y="15389"/>
            <a:ext cx="1124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Q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292731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19549" y="15389"/>
            <a:ext cx="1096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0541089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38785" y="15389"/>
            <a:ext cx="1077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7189800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50391" y="15389"/>
            <a:ext cx="10659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6213699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0698" y="15389"/>
            <a:ext cx="1115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448717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3140" y="15389"/>
            <a:ext cx="109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67082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34965" y="15389"/>
            <a:ext cx="981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80977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0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48440" y="15389"/>
            <a:ext cx="1167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W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864604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4358" y="15389"/>
            <a:ext cx="1091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967821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9301" y="15389"/>
            <a:ext cx="10670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5187953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2</a:t>
            </a:r>
            <a:endParaRPr lang="en-US" sz="2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8037182" y="15389"/>
            <a:ext cx="1079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AZ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0828755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1794" y="15389"/>
            <a:ext cx="10945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169455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7564" y="15389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4821743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9167" y="15389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2353860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9931" y="15389"/>
            <a:ext cx="1106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180949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0388" y="15389"/>
            <a:ext cx="1075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2948883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6800" y="15389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311000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6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0613" y="1538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989832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1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6725" y="15389"/>
            <a:ext cx="1109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4839165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2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8328" y="15389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7068495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D2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94891" y="15389"/>
            <a:ext cx="10214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19380338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78861" y="15389"/>
            <a:ext cx="10374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J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0467958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32373" y="15389"/>
            <a:ext cx="108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4887196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54815" y="15389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8075300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55429" y="15389"/>
            <a:ext cx="1160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1457619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3519" y="15389"/>
            <a:ext cx="11128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9426222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0313" y="15389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O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015069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PS0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33976" y="15389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51149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60613" y="15389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55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0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97107" y="15389"/>
            <a:ext cx="1119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Q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8741603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2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7564" y="15389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3896559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3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6800" y="15389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9921667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4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45775" y="15389"/>
            <a:ext cx="1070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9105241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5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05122" y="15389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U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3211521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7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23974" y="15389"/>
            <a:ext cx="1092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V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8674506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8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7950107" y="15389"/>
            <a:ext cx="1166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W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8500550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8242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smtClean="0"/>
              <a:t>SPS1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037311" y="15389"/>
            <a:ext cx="1079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B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6080578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457200" y="2286000"/>
            <a:ext cx="8229600" cy="707886"/>
          </a:xfrm>
          <a:prstGeom prst="rect">
            <a:avLst/>
          </a:prstGeom>
        </p:spPr>
        <p:txBody>
          <a:bodyPr>
            <a:sp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4000" b="1" dirty="0" smtClean="0"/>
              <a:t>End</a:t>
            </a:r>
            <a:endParaRPr 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6629019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10182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D09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31759" y="15389"/>
            <a:ext cx="984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9894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888" y="287338"/>
            <a:ext cx="8658225" cy="628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-1" y="0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enS01</a:t>
            </a:r>
            <a:endParaRPr lang="en-US" sz="2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8133363" y="15389"/>
            <a:ext cx="982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/>
              <a:t>S2, Fig 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3738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7</TotalTime>
  <Words>382</Words>
  <Application>Microsoft Office PowerPoint</Application>
  <PresentationFormat>On-screen Show (4:3)</PresentationFormat>
  <Paragraphs>154</Paragraphs>
  <Slides>7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8</vt:i4>
      </vt:variant>
    </vt:vector>
  </HeadingPairs>
  <TitlesOfParts>
    <vt:vector size="79" baseType="lpstr">
      <vt:lpstr>Office Theme</vt:lpstr>
      <vt:lpstr>S2 Measured and Modeled Profiles (note: vertical axis in microtesla (mT)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</dc:creator>
  <cp:lastModifiedBy>Rob</cp:lastModifiedBy>
  <cp:revision>40</cp:revision>
  <dcterms:created xsi:type="dcterms:W3CDTF">2015-12-14T19:51:37Z</dcterms:created>
  <dcterms:modified xsi:type="dcterms:W3CDTF">2016-01-28T20:10:15Z</dcterms:modified>
</cp:coreProperties>
</file>